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60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322F09C2-7D06-127A-F253-DC5E4C35FA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9ED1FB3A-5758-00F6-345A-56BEB6A765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852A4A71-9C7D-186F-27FC-A2B2A9FF3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B6771FBC-F941-C7B8-090A-352FE4943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6C5E8B12-647F-23FB-9E0C-AD90F98C7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3850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36E3556-5C79-8E31-1D3F-C2826FC218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C0EBA51D-0210-6FFA-7B64-F4C4317D33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D9EFD0A-5DF8-6DDB-C848-3B82CA14E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E8C2483E-4A6C-2DD4-0258-489D66460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D77874CA-BAF8-A09F-9C37-3B7AE71E9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70374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69A454C9-FBDD-250E-4661-F510CB5FFB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A9ADFE55-16F2-5456-CB95-A36208995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4286F39D-B6CF-03F1-8D17-2169901F6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526B96E3-9AC1-BD43-1C6C-78D8D7A24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B9F76D81-4F82-A552-1060-9B7E07D30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26433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337D8580-9C81-81EB-E057-6B31DA511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878109D0-EB2E-830F-7023-E5B66853F0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412B6744-31BB-70D6-967D-3FFC18CA3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E7BED298-53A8-962A-7453-A672BAC6C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D927D075-6B40-DFB3-21DB-4664D95CD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78643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C9F677D4-8DF1-349F-6BC4-22F6923F8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1DB6046D-5149-975E-4ED7-2F6CB0532D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71CEA48A-6BDE-E8C2-C050-B300D4077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2D6AD26A-F347-43F3-79B0-F70235ED2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8DF4E0C4-1BE7-4912-3196-7B8394E10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89831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F345B11-AEE2-D6CA-7182-7603BA39E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1330F5B7-37B3-17F0-6C3D-659B2F8BD0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28D6D7BD-0C6E-B3D9-1C7A-48332797A4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3F103DAF-7B7E-E71D-A571-53540B87A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05CB8F31-D2D4-12D8-D06A-B65B0119F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B2869F3E-C119-AECF-DF3B-D2AD631D7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25608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3A95DAF4-3314-2750-F8B5-BFB2D57543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5636CA37-65AD-D15B-A2D9-157BFD313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E753DDD2-C0CF-F419-B190-A152DE6821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13EBDBD1-6423-6E43-2680-482DB38425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9F876B5A-7603-BE78-8E37-92F83A8E55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A207DFDD-C9F3-38BA-7DF2-E8A86A265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783490E4-5F09-8E84-5B71-F2885F659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E292D2D4-6C53-1E7A-9513-50516A57D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01137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CCE68777-2B9F-0836-9D74-7BD0A3B00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C41019EE-BDD6-01D7-5E55-305F566BA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99CDA91E-830A-650B-1589-3C6915EDD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DB591DAA-F785-A9C3-E8C3-077948AD2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4764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8C4E72E8-F63D-B712-3CC0-11F0F9094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7FBD0E79-5CAD-6E4D-2217-57E788E32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B9626950-60D0-8090-CEFF-054FCC467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6712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4AAA0B1B-AD7C-1D5A-31C8-8496C4A99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F865FAE8-E90C-A84F-39D4-C9CF88554B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4996646E-11A8-9E6A-065D-F179EAEA6C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BB90192A-F8C2-00B7-B4F6-292599226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2AA4CC8E-7B66-2024-BBF4-A8A9A2EED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84C4ECAA-C543-50DE-CC5D-276326B60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3584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54EA9A89-52AE-1A8D-72E3-C9A45902A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AEE4A938-9413-A843-4332-E85848BD8E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A186803F-782C-DEEE-7973-154DDE6997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21B33772-363E-8940-11CB-E5CEFFDE5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1BAC91A3-4E33-4362-EE9B-BF270ECCE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68EF649E-F3FD-E471-3E7E-72A051703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50984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DEF18B43-B435-2E2A-7B78-C361673F1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971EA8B3-721C-D01C-6867-DC0D0A8AC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27E6294-6AE1-0FC4-E99F-1A1DD286A4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94B21-0664-45DE-9641-A38CCD2E25F3}" type="datetimeFigureOut">
              <a:rPr lang="he-IL" smtClean="0"/>
              <a:t>י"ט/תשרי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8F5FAC9D-5F7C-0ADD-214B-102C764E84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9573CFD-0246-D994-3C77-B4AB705481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76E493-222C-4381-9325-34525E6D11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4503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תמונה 144"/>
          <p:cNvPicPr>
            <a:picLocks noChangeAspect="1"/>
          </p:cNvPicPr>
          <p:nvPr/>
        </p:nvPicPr>
        <p:blipFill rotWithShape="1">
          <a:blip r:embed="rId2"/>
          <a:srcRect r="31956" b="776"/>
          <a:stretch/>
        </p:blipFill>
        <p:spPr>
          <a:xfrm>
            <a:off x="4158659" y="935105"/>
            <a:ext cx="3866443" cy="2819751"/>
          </a:xfrm>
          <a:prstGeom prst="rect">
            <a:avLst/>
          </a:prstGeom>
        </p:spPr>
      </p:pic>
      <p:pic>
        <p:nvPicPr>
          <p:cNvPr id="146" name="תמונה 145"/>
          <p:cNvPicPr>
            <a:picLocks noChangeAspect="1"/>
          </p:cNvPicPr>
          <p:nvPr/>
        </p:nvPicPr>
        <p:blipFill rotWithShape="1">
          <a:blip r:embed="rId3"/>
          <a:srcRect r="26141" b="-104"/>
          <a:stretch/>
        </p:blipFill>
        <p:spPr>
          <a:xfrm>
            <a:off x="8215296" y="927450"/>
            <a:ext cx="3877850" cy="2850057"/>
          </a:xfrm>
          <a:prstGeom prst="rect">
            <a:avLst/>
          </a:prstGeom>
        </p:spPr>
      </p:pic>
      <p:pic>
        <p:nvPicPr>
          <p:cNvPr id="3" name="תמונה 2"/>
          <p:cNvPicPr>
            <a:picLocks noChangeAspect="1"/>
          </p:cNvPicPr>
          <p:nvPr/>
        </p:nvPicPr>
        <p:blipFill rotWithShape="1">
          <a:blip r:embed="rId4"/>
          <a:srcRect r="26291" b="-1455"/>
          <a:stretch/>
        </p:blipFill>
        <p:spPr>
          <a:xfrm>
            <a:off x="114246" y="927450"/>
            <a:ext cx="3854219" cy="2876772"/>
          </a:xfrm>
          <a:prstGeom prst="rect">
            <a:avLst/>
          </a:prstGeom>
        </p:spPr>
      </p:pic>
      <p:sp>
        <p:nvSpPr>
          <p:cNvPr id="2" name="תיבת טקסט 1">
            <a:extLst>
              <a:ext uri="{FF2B5EF4-FFF2-40B4-BE49-F238E27FC236}">
                <a16:creationId xmlns:a16="http://schemas.microsoft.com/office/drawing/2014/main" id="{B63E6584-A759-7018-CC3C-80DCFF97EBD7}"/>
              </a:ext>
            </a:extLst>
          </p:cNvPr>
          <p:cNvSpPr txBox="1"/>
          <p:nvPr/>
        </p:nvSpPr>
        <p:spPr>
          <a:xfrm>
            <a:off x="222514" y="4010584"/>
            <a:ext cx="11207486" cy="58477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dirty="0"/>
              <a:t>Figure S1 A-C : Kaplan Meier estimates of local control (A), disease free (B) and overall survival (C) by  EGFR N=13, KRAS N=10 and no mutation N=22. </a:t>
            </a:r>
            <a:endParaRPr lang="he-IL" sz="1600" dirty="0"/>
          </a:p>
        </p:txBody>
      </p:sp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9DC09F89-2C33-59CB-C04B-ACF3C13F4AB6}"/>
              </a:ext>
            </a:extLst>
          </p:cNvPr>
          <p:cNvSpPr txBox="1"/>
          <p:nvPr/>
        </p:nvSpPr>
        <p:spPr>
          <a:xfrm>
            <a:off x="222514" y="935105"/>
            <a:ext cx="3233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A</a:t>
            </a:r>
            <a:endParaRPr lang="he-IL" dirty="0"/>
          </a:p>
        </p:txBody>
      </p:sp>
      <p:sp>
        <p:nvSpPr>
          <p:cNvPr id="8" name="תיבת טקסט 7">
            <a:extLst>
              <a:ext uri="{FF2B5EF4-FFF2-40B4-BE49-F238E27FC236}">
                <a16:creationId xmlns:a16="http://schemas.microsoft.com/office/drawing/2014/main" id="{59FE0020-F836-1315-803A-523A0670F874}"/>
              </a:ext>
            </a:extLst>
          </p:cNvPr>
          <p:cNvSpPr txBox="1"/>
          <p:nvPr/>
        </p:nvSpPr>
        <p:spPr>
          <a:xfrm>
            <a:off x="4158659" y="971577"/>
            <a:ext cx="39387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B</a:t>
            </a:r>
            <a:endParaRPr lang="he-IL" dirty="0"/>
          </a:p>
        </p:txBody>
      </p:sp>
      <p:sp>
        <p:nvSpPr>
          <p:cNvPr id="9" name="תיבת טקסט 8">
            <a:extLst>
              <a:ext uri="{FF2B5EF4-FFF2-40B4-BE49-F238E27FC236}">
                <a16:creationId xmlns:a16="http://schemas.microsoft.com/office/drawing/2014/main" id="{3D974019-D15C-CC50-E2A3-1B62CCE24CE1}"/>
              </a:ext>
            </a:extLst>
          </p:cNvPr>
          <p:cNvSpPr txBox="1"/>
          <p:nvPr/>
        </p:nvSpPr>
        <p:spPr>
          <a:xfrm>
            <a:off x="8272961" y="970104"/>
            <a:ext cx="30714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C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061274499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44</Words>
  <Application>Microsoft Office PowerPoint</Application>
  <PresentationFormat>מסך רחב</PresentationFormat>
  <Paragraphs>4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ערכת נושא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Yaron Appel</dc:creator>
  <cp:lastModifiedBy>yael appel</cp:lastModifiedBy>
  <cp:revision>24</cp:revision>
  <dcterms:created xsi:type="dcterms:W3CDTF">2022-07-09T05:54:40Z</dcterms:created>
  <dcterms:modified xsi:type="dcterms:W3CDTF">2023-10-04T15:57:45Z</dcterms:modified>
</cp:coreProperties>
</file>